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65"/>
  </p:normalViewPr>
  <p:slideViewPr>
    <p:cSldViewPr snapToGrid="0" snapToObjects="1">
      <p:cViewPr varScale="1">
        <p:scale>
          <a:sx n="105" d="100"/>
          <a:sy n="105" d="100"/>
        </p:scale>
        <p:origin x="18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aekikiyoshi/Desktop/&#21313;&#20108;&#25351;&#33144;&#28528;&#30221;&#32925;&#22178;&#32990;&#31359;&#36890;/supplementary%20figure%20grap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800" b="1" i="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lood test data in chronological order</a:t>
            </a:r>
            <a:r>
              <a:rPr lang="ja-JP" altLang="ja-JP" sz="1800" b="1" i="0" baseline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ja-JP" b="1"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1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WBC (x10^2/μL)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432FF"/>
              </a:solidFill>
              <a:ln w="9525">
                <a:solidFill>
                  <a:srgbClr val="0432FF"/>
                </a:solidFill>
              </a:ln>
              <a:effectLst/>
            </c:spPr>
          </c:marker>
          <c:cat>
            <c:strRef>
              <c:f>Sheet1!$C$2:$V$2</c:f>
              <c:strCache>
                <c:ptCount val="20"/>
                <c:pt idx="0">
                  <c:v>day1</c:v>
                </c:pt>
                <c:pt idx="1">
                  <c:v>day2</c:v>
                </c:pt>
                <c:pt idx="2">
                  <c:v>day4</c:v>
                </c:pt>
                <c:pt idx="3">
                  <c:v>day7</c:v>
                </c:pt>
                <c:pt idx="4">
                  <c:v>day9</c:v>
                </c:pt>
                <c:pt idx="5">
                  <c:v>day11</c:v>
                </c:pt>
                <c:pt idx="6">
                  <c:v>day14</c:v>
                </c:pt>
                <c:pt idx="7">
                  <c:v>day16</c:v>
                </c:pt>
                <c:pt idx="8">
                  <c:v>day18</c:v>
                </c:pt>
                <c:pt idx="9">
                  <c:v>day21</c:v>
                </c:pt>
                <c:pt idx="10">
                  <c:v>day25</c:v>
                </c:pt>
                <c:pt idx="11">
                  <c:v>day29</c:v>
                </c:pt>
                <c:pt idx="12">
                  <c:v>day31</c:v>
                </c:pt>
                <c:pt idx="13">
                  <c:v>day32</c:v>
                </c:pt>
                <c:pt idx="14">
                  <c:v>day35</c:v>
                </c:pt>
                <c:pt idx="15">
                  <c:v>day38</c:v>
                </c:pt>
                <c:pt idx="16">
                  <c:v>day43</c:v>
                </c:pt>
                <c:pt idx="17">
                  <c:v>day45</c:v>
                </c:pt>
                <c:pt idx="18">
                  <c:v>day49</c:v>
                </c:pt>
                <c:pt idx="19">
                  <c:v>day51</c:v>
                </c:pt>
              </c:strCache>
            </c:strRef>
          </c:cat>
          <c:val>
            <c:numRef>
              <c:f>Sheet1!$C$3:$V$3</c:f>
              <c:numCache>
                <c:formatCode>General</c:formatCode>
                <c:ptCount val="20"/>
                <c:pt idx="0">
                  <c:v>133</c:v>
                </c:pt>
                <c:pt idx="1">
                  <c:v>128</c:v>
                </c:pt>
                <c:pt idx="2">
                  <c:v>111</c:v>
                </c:pt>
                <c:pt idx="3">
                  <c:v>115</c:v>
                </c:pt>
                <c:pt idx="4">
                  <c:v>104</c:v>
                </c:pt>
                <c:pt idx="5">
                  <c:v>65</c:v>
                </c:pt>
                <c:pt idx="6">
                  <c:v>44</c:v>
                </c:pt>
                <c:pt idx="7">
                  <c:v>44</c:v>
                </c:pt>
                <c:pt idx="8">
                  <c:v>32</c:v>
                </c:pt>
                <c:pt idx="9">
                  <c:v>51</c:v>
                </c:pt>
                <c:pt idx="10">
                  <c:v>48</c:v>
                </c:pt>
                <c:pt idx="11">
                  <c:v>50</c:v>
                </c:pt>
                <c:pt idx="12">
                  <c:v>66</c:v>
                </c:pt>
                <c:pt idx="13">
                  <c:v>66</c:v>
                </c:pt>
                <c:pt idx="14">
                  <c:v>44</c:v>
                </c:pt>
                <c:pt idx="15">
                  <c:v>50</c:v>
                </c:pt>
                <c:pt idx="16">
                  <c:v>90</c:v>
                </c:pt>
                <c:pt idx="17">
                  <c:v>85</c:v>
                </c:pt>
                <c:pt idx="18">
                  <c:v>77</c:v>
                </c:pt>
                <c:pt idx="19">
                  <c:v>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D90-3940-AD90-70E00C9C24FB}"/>
            </c:ext>
          </c:extLst>
        </c:ser>
        <c:ser>
          <c:idx val="1"/>
          <c:order val="1"/>
          <c:tx>
            <c:strRef>
              <c:f>Sheet1!$B$4</c:f>
              <c:strCache>
                <c:ptCount val="1"/>
                <c:pt idx="0">
                  <c:v>CRP (mg/dL)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Sheet1!$C$2:$V$2</c:f>
              <c:strCache>
                <c:ptCount val="20"/>
                <c:pt idx="0">
                  <c:v>day1</c:v>
                </c:pt>
                <c:pt idx="1">
                  <c:v>day2</c:v>
                </c:pt>
                <c:pt idx="2">
                  <c:v>day4</c:v>
                </c:pt>
                <c:pt idx="3">
                  <c:v>day7</c:v>
                </c:pt>
                <c:pt idx="4">
                  <c:v>day9</c:v>
                </c:pt>
                <c:pt idx="5">
                  <c:v>day11</c:v>
                </c:pt>
                <c:pt idx="6">
                  <c:v>day14</c:v>
                </c:pt>
                <c:pt idx="7">
                  <c:v>day16</c:v>
                </c:pt>
                <c:pt idx="8">
                  <c:v>day18</c:v>
                </c:pt>
                <c:pt idx="9">
                  <c:v>day21</c:v>
                </c:pt>
                <c:pt idx="10">
                  <c:v>day25</c:v>
                </c:pt>
                <c:pt idx="11">
                  <c:v>day29</c:v>
                </c:pt>
                <c:pt idx="12">
                  <c:v>day31</c:v>
                </c:pt>
                <c:pt idx="13">
                  <c:v>day32</c:v>
                </c:pt>
                <c:pt idx="14">
                  <c:v>day35</c:v>
                </c:pt>
                <c:pt idx="15">
                  <c:v>day38</c:v>
                </c:pt>
                <c:pt idx="16">
                  <c:v>day43</c:v>
                </c:pt>
                <c:pt idx="17">
                  <c:v>day45</c:v>
                </c:pt>
                <c:pt idx="18">
                  <c:v>day49</c:v>
                </c:pt>
                <c:pt idx="19">
                  <c:v>day51</c:v>
                </c:pt>
              </c:strCache>
            </c:strRef>
          </c:cat>
          <c:val>
            <c:numRef>
              <c:f>Sheet1!$C$4:$V$4</c:f>
              <c:numCache>
                <c:formatCode>General</c:formatCode>
                <c:ptCount val="20"/>
                <c:pt idx="0">
                  <c:v>41.72</c:v>
                </c:pt>
                <c:pt idx="1">
                  <c:v>38.35</c:v>
                </c:pt>
                <c:pt idx="2">
                  <c:v>18.86</c:v>
                </c:pt>
                <c:pt idx="3">
                  <c:v>10.16</c:v>
                </c:pt>
                <c:pt idx="4">
                  <c:v>5.03</c:v>
                </c:pt>
                <c:pt idx="5">
                  <c:v>1.86</c:v>
                </c:pt>
                <c:pt idx="6">
                  <c:v>1.05</c:v>
                </c:pt>
                <c:pt idx="7">
                  <c:v>1.02</c:v>
                </c:pt>
                <c:pt idx="8">
                  <c:v>3.55</c:v>
                </c:pt>
                <c:pt idx="9">
                  <c:v>2.9</c:v>
                </c:pt>
                <c:pt idx="10">
                  <c:v>3.37</c:v>
                </c:pt>
                <c:pt idx="11">
                  <c:v>3.23</c:v>
                </c:pt>
                <c:pt idx="12">
                  <c:v>5.25</c:v>
                </c:pt>
                <c:pt idx="13">
                  <c:v>7.66</c:v>
                </c:pt>
                <c:pt idx="14">
                  <c:v>8.27</c:v>
                </c:pt>
                <c:pt idx="15">
                  <c:v>3.64</c:v>
                </c:pt>
                <c:pt idx="16">
                  <c:v>10.43</c:v>
                </c:pt>
                <c:pt idx="17">
                  <c:v>18.489999999999998</c:v>
                </c:pt>
                <c:pt idx="18">
                  <c:v>3.56</c:v>
                </c:pt>
                <c:pt idx="19">
                  <c:v>1.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D90-3940-AD90-70E00C9C24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79430879"/>
        <c:axId val="537078895"/>
      </c:lineChart>
      <c:catAx>
        <c:axId val="8794308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7078895"/>
        <c:crosses val="autoZero"/>
        <c:auto val="1"/>
        <c:lblAlgn val="ctr"/>
        <c:lblOffset val="100"/>
        <c:noMultiLvlLbl val="0"/>
      </c:catAx>
      <c:valAx>
        <c:axId val="53707889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794308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zero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0875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253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8654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518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4821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3339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463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9238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1697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261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86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C11C1-1B5B-CC43-B4BE-9F180A02142A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080759-6A70-DC40-918E-A57A735D43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5587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ED2FA7C8-2BB6-9B43-AAE9-E338DB8059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9869994"/>
              </p:ext>
            </p:extLst>
          </p:nvPr>
        </p:nvGraphicFramePr>
        <p:xfrm>
          <a:off x="1089025" y="792481"/>
          <a:ext cx="6965950" cy="5118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7A7B20D-2FAC-D149-94C8-5438F3AFEA9A}"/>
              </a:ext>
            </a:extLst>
          </p:cNvPr>
          <p:cNvSpPr txBox="1"/>
          <p:nvPr/>
        </p:nvSpPr>
        <p:spPr>
          <a:xfrm>
            <a:off x="310243" y="277585"/>
            <a:ext cx="2764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. 2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FD28632-1BAE-8448-BCB4-592413A98BBB}"/>
              </a:ext>
            </a:extLst>
          </p:cNvPr>
          <p:cNvSpPr txBox="1"/>
          <p:nvPr/>
        </p:nvSpPr>
        <p:spPr>
          <a:xfrm>
            <a:off x="1534885" y="6077494"/>
            <a:ext cx="32931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ay   1:  Admission day</a:t>
            </a:r>
          </a:p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ay 42:  Surgery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7232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9</Words>
  <Application>Microsoft Macintosh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伯潔</dc:creator>
  <cp:lastModifiedBy>佐伯 潔</cp:lastModifiedBy>
  <cp:revision>5</cp:revision>
  <dcterms:created xsi:type="dcterms:W3CDTF">2025-01-13T02:37:51Z</dcterms:created>
  <dcterms:modified xsi:type="dcterms:W3CDTF">2025-02-11T00:41:12Z</dcterms:modified>
</cp:coreProperties>
</file>